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17F779-DB15-40B2-B051-4A907BF53E6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73A58D-780A-40B8-ABED-A6FD0857FFA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848004-DDC4-4189-875F-62002D44E27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1910C7-1103-4C2A-966A-1FDA2342DA3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5F904F-8F22-4844-99D7-092C118E4E9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A5E874-C867-41F6-A32F-4D3FD6115AF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FB32EF-D738-4073-91CF-D3A2881B95A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180CB1-7115-4A46-9FFB-53FB744C0B3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FF57B8-2067-4593-B200-629CCF7DABD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E92B46-5ADF-4849-BAE5-A4433FA107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3982AB-EEF3-4BD3-8B25-151CBE8BF0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2E4BF7-C1D8-4E24-8DBB-5AC412DF52B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032A429-F737-4A5D-AEA2-5C81B82413D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1066680" y="2998800"/>
            <a:ext cx="3519720" cy="1598760"/>
          </a:xfrm>
          <a:prstGeom prst="rect">
            <a:avLst/>
          </a:prstGeom>
          <a:ln w="0">
            <a:noFill/>
          </a:ln>
        </p:spPr>
      </p:pic>
      <p:pic>
        <p:nvPicPr>
          <p:cNvPr id="42" name="Imagen 3" descr=""/>
          <p:cNvPicPr/>
          <p:nvPr/>
        </p:nvPicPr>
        <p:blipFill>
          <a:blip r:embed="rId2"/>
          <a:srcRect l="47544" t="55193" r="26754" b="20106"/>
          <a:stretch/>
        </p:blipFill>
        <p:spPr>
          <a:xfrm>
            <a:off x="4626000" y="3048120"/>
            <a:ext cx="3298680" cy="1981080"/>
          </a:xfrm>
          <a:prstGeom prst="rect">
            <a:avLst/>
          </a:prstGeom>
          <a:ln w="0">
            <a:noFill/>
          </a:ln>
        </p:spPr>
      </p:pic>
      <p:sp>
        <p:nvSpPr>
          <p:cNvPr id="43" name="4 CuadroTexto"/>
          <p:cNvSpPr/>
          <p:nvPr/>
        </p:nvSpPr>
        <p:spPr>
          <a:xfrm rot="18000000">
            <a:off x="1991160" y="1733040"/>
            <a:ext cx="2171160" cy="405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VEGF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Calibri"/>
              </a:rPr>
              <a:t>165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 + EndoG -F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6 CuadroTexto"/>
          <p:cNvSpPr/>
          <p:nvPr/>
        </p:nvSpPr>
        <p:spPr>
          <a:xfrm rot="18000000">
            <a:off x="1354680" y="2301840"/>
            <a:ext cx="992880" cy="405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VEGF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Calibri"/>
              </a:rPr>
              <a:t>165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7 CuadroTexto"/>
          <p:cNvSpPr/>
          <p:nvPr/>
        </p:nvSpPr>
        <p:spPr>
          <a:xfrm rot="18000000">
            <a:off x="3760200" y="1647720"/>
            <a:ext cx="2119320" cy="405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VEGF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Calibri"/>
              </a:rPr>
              <a:t>121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 + EndoG-F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8 CuadroTexto"/>
          <p:cNvSpPr/>
          <p:nvPr/>
        </p:nvSpPr>
        <p:spPr>
          <a:xfrm rot="18000000">
            <a:off x="3101040" y="2295360"/>
            <a:ext cx="992880" cy="405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VEGF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Calibri"/>
              </a:rPr>
              <a:t>121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9 CuadroTexto"/>
          <p:cNvSpPr/>
          <p:nvPr/>
        </p:nvSpPr>
        <p:spPr>
          <a:xfrm rot="18000000">
            <a:off x="5067720" y="1748880"/>
            <a:ext cx="2171160" cy="405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VEGF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Calibri"/>
              </a:rPr>
              <a:t>165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 + EndoG -F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10 CuadroTexto"/>
          <p:cNvSpPr/>
          <p:nvPr/>
        </p:nvSpPr>
        <p:spPr>
          <a:xfrm rot="18000000">
            <a:off x="4769280" y="2317680"/>
            <a:ext cx="992880" cy="405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VEGF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Calibri"/>
              </a:rPr>
              <a:t>165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11 CuadroTexto"/>
          <p:cNvSpPr/>
          <p:nvPr/>
        </p:nvSpPr>
        <p:spPr>
          <a:xfrm rot="18000000">
            <a:off x="6219360" y="1675800"/>
            <a:ext cx="2119320" cy="405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VEGF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Calibri"/>
              </a:rPr>
              <a:t>121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 + EndoG-F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12 CuadroTexto"/>
          <p:cNvSpPr/>
          <p:nvPr/>
        </p:nvSpPr>
        <p:spPr>
          <a:xfrm rot="18000000">
            <a:off x="5907600" y="2324160"/>
            <a:ext cx="992880" cy="405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VEGF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Calibri"/>
              </a:rPr>
              <a:t>121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5 CuadroTexto"/>
          <p:cNvSpPr/>
          <p:nvPr/>
        </p:nvSpPr>
        <p:spPr>
          <a:xfrm>
            <a:off x="7966080" y="2971800"/>
            <a:ext cx="682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50 Kd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14 CuadroTexto"/>
          <p:cNvSpPr/>
          <p:nvPr/>
        </p:nvSpPr>
        <p:spPr>
          <a:xfrm>
            <a:off x="7966080" y="3440160"/>
            <a:ext cx="682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37 Kd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15 CuadroTexto"/>
          <p:cNvSpPr/>
          <p:nvPr/>
        </p:nvSpPr>
        <p:spPr>
          <a:xfrm>
            <a:off x="7966080" y="4049640"/>
            <a:ext cx="682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25 Kd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16 CuadroTexto"/>
          <p:cNvSpPr/>
          <p:nvPr/>
        </p:nvSpPr>
        <p:spPr>
          <a:xfrm>
            <a:off x="7966080" y="4260960"/>
            <a:ext cx="682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20 Kd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17 CuadroTexto"/>
          <p:cNvSpPr/>
          <p:nvPr/>
        </p:nvSpPr>
        <p:spPr>
          <a:xfrm>
            <a:off x="7966080" y="4519440"/>
            <a:ext cx="682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15 Kd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18 CuadroTexto"/>
          <p:cNvSpPr/>
          <p:nvPr/>
        </p:nvSpPr>
        <p:spPr>
          <a:xfrm>
            <a:off x="7966080" y="4776840"/>
            <a:ext cx="682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10 Kd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19 CuadroTexto"/>
          <p:cNvSpPr/>
          <p:nvPr/>
        </p:nvSpPr>
        <p:spPr>
          <a:xfrm>
            <a:off x="346320" y="2971800"/>
            <a:ext cx="682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50 Kd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20 CuadroTexto"/>
          <p:cNvSpPr/>
          <p:nvPr/>
        </p:nvSpPr>
        <p:spPr>
          <a:xfrm>
            <a:off x="346320" y="3440160"/>
            <a:ext cx="682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37 Kd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21 CuadroTexto"/>
          <p:cNvSpPr/>
          <p:nvPr/>
        </p:nvSpPr>
        <p:spPr>
          <a:xfrm>
            <a:off x="346320" y="4049640"/>
            <a:ext cx="682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25 Kd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22 CuadroTexto"/>
          <p:cNvSpPr/>
          <p:nvPr/>
        </p:nvSpPr>
        <p:spPr>
          <a:xfrm>
            <a:off x="346320" y="4260960"/>
            <a:ext cx="682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20 Kd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23 CuadroTexto"/>
          <p:cNvSpPr/>
          <p:nvPr/>
        </p:nvSpPr>
        <p:spPr>
          <a:xfrm>
            <a:off x="1467000" y="5334120"/>
            <a:ext cx="2469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Non-reducing condit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25 CuadroTexto"/>
          <p:cNvSpPr/>
          <p:nvPr/>
        </p:nvSpPr>
        <p:spPr>
          <a:xfrm>
            <a:off x="5376240" y="5334120"/>
            <a:ext cx="205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Reducing condit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1116000" y="5229360"/>
            <a:ext cx="338472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4643280" y="5229360"/>
            <a:ext cx="338472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6793920" y="115920"/>
            <a:ext cx="2241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Supplementary Fig. 1 Catena et al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0-29T07:38:15Z</dcterms:created>
  <dc:creator>alfonso calvo</dc:creator>
  <dc:description/>
  <dc:language>en-US</dc:language>
  <cp:lastModifiedBy>alfonso calvo</cp:lastModifiedBy>
  <dcterms:modified xsi:type="dcterms:W3CDTF">2010-10-29T07:40:37Z</dcterms:modified>
  <cp:revision>1</cp:revision>
  <dc:subject/>
  <dc:title>Diapositiva 1</dc:title>
</cp:coreProperties>
</file>